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429BCE-5B07-4081-9AEC-317A23A88C5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B24E12-9DB0-4F87-A76E-72EC85D2C29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02501B-C7C0-4B32-845B-75016BD8D15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176ADC-31CF-493D-8F4F-320E92DDD7E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C1BA91-DA23-46A5-B63E-7241CE3C48E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854EB6-C408-4C25-9A84-CF8A97D55BB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466A18-2578-4A59-BCFE-CBDDAA27082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EFD74F-2BC9-450C-A4A7-A13A01294AE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C5578C-C9A5-4715-BE7C-8148BBE03EA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91EF44-35E3-4600-8987-7E9D6AAC66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D78324-AE67-4EB0-A4FD-7C5E006C93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93DBB3-835D-461A-9164-4668B96FD0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6A3C969-B488-4568-8A11-EC393485676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274840" y="5910120"/>
            <a:ext cx="2306520" cy="2519280"/>
            <a:chOff x="2274840" y="5910120"/>
            <a:chExt cx="2306520" cy="2519280"/>
          </a:xfrm>
        </p:grpSpPr>
        <p:pic>
          <p:nvPicPr>
            <p:cNvPr id="42" name="" descr=""/>
            <p:cNvPicPr/>
            <p:nvPr/>
          </p:nvPicPr>
          <p:blipFill>
            <a:blip r:embed="rId1"/>
            <a:stretch/>
          </p:blipFill>
          <p:spPr>
            <a:xfrm>
              <a:off x="2274840" y="6113520"/>
              <a:ext cx="2273040" cy="834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" descr=""/>
            <p:cNvPicPr/>
            <p:nvPr/>
          </p:nvPicPr>
          <p:blipFill>
            <a:blip r:embed="rId2"/>
            <a:stretch/>
          </p:blipFill>
          <p:spPr>
            <a:xfrm>
              <a:off x="2346120" y="7365960"/>
              <a:ext cx="2235240" cy="835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"/>
            <p:cNvSpPr/>
            <p:nvPr/>
          </p:nvSpPr>
          <p:spPr>
            <a:xfrm>
              <a:off x="2441880" y="5910120"/>
              <a:ext cx="1957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C. taiwanensis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chromosome 1 (3.4 Mb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2490120" y="8213760"/>
              <a:ext cx="1978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R. solanacearum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chromosome 2 (2 Mb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2371320" y="6918120"/>
              <a:ext cx="203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R. solanacearum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chromosome 1 (3.7Mb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2451240" y="7205760"/>
              <a:ext cx="1986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C. taiwanensis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 chromosome 2 (2.5 Mb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8" name=""/>
          <p:cNvGrpSpPr/>
          <p:nvPr/>
        </p:nvGrpSpPr>
        <p:grpSpPr>
          <a:xfrm>
            <a:off x="2176560" y="936720"/>
            <a:ext cx="2504160" cy="3225960"/>
            <a:chOff x="2176560" y="936720"/>
            <a:chExt cx="2504160" cy="3225960"/>
          </a:xfrm>
        </p:grpSpPr>
        <p:sp>
          <p:nvSpPr>
            <p:cNvPr id="49" name=""/>
            <p:cNvSpPr/>
            <p:nvPr/>
          </p:nvSpPr>
          <p:spPr>
            <a:xfrm>
              <a:off x="2847960" y="936720"/>
              <a:ext cx="1412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C. necato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2925720" y="1203480"/>
              <a:ext cx="761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C. basilensi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2990880" y="1359000"/>
              <a:ext cx="767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C. oxalatic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2884680" y="1528920"/>
              <a:ext cx="889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800" spc="-1" strike="noStrike">
                  <a:solidFill>
                    <a:srgbClr val="000000"/>
                  </a:solidFill>
                  <a:latin typeface="Arial"/>
                </a:rPr>
                <a:t>C. taiwanensi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2875320" y="1697040"/>
              <a:ext cx="776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C. respiracul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3016800" y="1873440"/>
              <a:ext cx="605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C. gilardi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3015360" y="2043000"/>
              <a:ext cx="918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C. metalliduran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2931840" y="2208240"/>
              <a:ext cx="720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C. paucul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2849400" y="2368440"/>
              <a:ext cx="880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C. campinensi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3017160" y="2540160"/>
              <a:ext cx="654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R. picketti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2967480" y="2703600"/>
              <a:ext cx="709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R. insidios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3008160" y="2867040"/>
              <a:ext cx="1141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R. mannitolilytic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2938320" y="3036960"/>
              <a:ext cx="997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800" spc="-1" strike="noStrike">
                  <a:solidFill>
                    <a:srgbClr val="000000"/>
                  </a:solidFill>
                  <a:latin typeface="Arial"/>
                </a:rPr>
                <a:t>R. solanacearu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2911680" y="3208320"/>
              <a:ext cx="621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R. syzygi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3600720" y="3382920"/>
              <a:ext cx="1080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Alcaligenes faecali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3092760" y="3544920"/>
              <a:ext cx="1133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Burkholderia cepaci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3062880" y="3716280"/>
              <a:ext cx="979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800" spc="-1" strike="noStrike">
                  <a:solidFill>
                    <a:srgbClr val="000000"/>
                  </a:solidFill>
                  <a:latin typeface="Arial"/>
                </a:rPr>
                <a:t>Pandoraea apist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2655720" y="4118040"/>
              <a:ext cx="1226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3076200" y="3916440"/>
              <a:ext cx="363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5%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8" name=""/>
            <p:cNvGrpSpPr/>
            <p:nvPr/>
          </p:nvGrpSpPr>
          <p:grpSpPr>
            <a:xfrm>
              <a:off x="2176560" y="1050840"/>
              <a:ext cx="1440720" cy="2776680"/>
              <a:chOff x="2176560" y="1050840"/>
              <a:chExt cx="1440720" cy="2776680"/>
            </a:xfrm>
          </p:grpSpPr>
          <p:sp>
            <p:nvSpPr>
              <p:cNvPr id="69" name=""/>
              <p:cNvSpPr/>
              <p:nvPr/>
            </p:nvSpPr>
            <p:spPr>
              <a:xfrm flipH="1">
                <a:off x="2735640" y="1050840"/>
                <a:ext cx="2160" cy="387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2714400" y="1235160"/>
                <a:ext cx="0" cy="723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2714400" y="1235160"/>
                <a:ext cx="22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2760120" y="1311480"/>
                <a:ext cx="2246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2803320" y="1473120"/>
                <a:ext cx="2354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2801520" y="1643040"/>
                <a:ext cx="126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 flipV="1">
                <a:off x="2762280" y="1805040"/>
                <a:ext cx="16020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2788920" y="1981440"/>
                <a:ext cx="266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2761200" y="1317600"/>
                <a:ext cx="0" cy="231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2762280" y="1557360"/>
                <a:ext cx="3924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 flipH="1">
                <a:off x="2802600" y="1473120"/>
                <a:ext cx="720" cy="168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2714400" y="1959120"/>
                <a:ext cx="3888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2680560" y="1604880"/>
                <a:ext cx="30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 flipV="1">
                <a:off x="2734560" y="1437840"/>
                <a:ext cx="2196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 flipV="1">
                <a:off x="2761200" y="2099880"/>
                <a:ext cx="2232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>
                <a:off x="2760120" y="1806480"/>
                <a:ext cx="0" cy="287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>
                <a:off x="2823840" y="2976480"/>
                <a:ext cx="0" cy="258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>
                <a:off x="2786760" y="1984320"/>
                <a:ext cx="0" cy="247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2788920" y="2235240"/>
                <a:ext cx="96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>
                <a:off x="2887560" y="2149560"/>
                <a:ext cx="720" cy="165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2887560" y="2149560"/>
                <a:ext cx="144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2887560" y="2316240"/>
                <a:ext cx="7092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2680560" y="1608120"/>
                <a:ext cx="0" cy="863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2678400" y="2478240"/>
                <a:ext cx="1918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2483280" y="2046240"/>
                <a:ext cx="0" cy="873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2481840" y="2046240"/>
                <a:ext cx="198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2481840" y="2919600"/>
                <a:ext cx="2728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2858760" y="2651040"/>
                <a:ext cx="1918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2863080" y="2811600"/>
                <a:ext cx="144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 flipH="1">
                <a:off x="2750400" y="2735280"/>
                <a:ext cx="720" cy="366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2755800" y="2735280"/>
                <a:ext cx="96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>
                <a:off x="2856600" y="2651040"/>
                <a:ext cx="0" cy="162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2846160" y="3146400"/>
                <a:ext cx="720" cy="173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>
                <a:off x="2824920" y="2976480"/>
                <a:ext cx="2088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>
                <a:off x="2844000" y="3146400"/>
                <a:ext cx="113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>
                <a:off x="2846160" y="3321000"/>
                <a:ext cx="90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 flipV="1">
                <a:off x="2822760" y="3234960"/>
                <a:ext cx="2196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>
                <a:off x="2750400" y="3105360"/>
                <a:ext cx="752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 flipH="1">
                <a:off x="2176560" y="2478240"/>
                <a:ext cx="2160" cy="1123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>
                <a:off x="2178720" y="2478240"/>
                <a:ext cx="30528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2176560" y="3606840"/>
                <a:ext cx="95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>
                <a:off x="2271960" y="3495600"/>
                <a:ext cx="0" cy="249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2269800" y="3743280"/>
                <a:ext cx="302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2571120" y="3826080"/>
                <a:ext cx="509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2269800" y="3495600"/>
                <a:ext cx="1347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>
                <a:off x="2572200" y="3648240"/>
                <a:ext cx="556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>
                <a:off x="2571120" y="3649680"/>
                <a:ext cx="720" cy="177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>
                <a:off x="2736720" y="1050840"/>
                <a:ext cx="16956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17" name=""/>
          <p:cNvGrpSpPr/>
          <p:nvPr/>
        </p:nvGrpSpPr>
        <p:grpSpPr>
          <a:xfrm>
            <a:off x="2022480" y="4448160"/>
            <a:ext cx="2813040" cy="1096920"/>
            <a:chOff x="2022480" y="4448160"/>
            <a:chExt cx="2813040" cy="1096920"/>
          </a:xfrm>
        </p:grpSpPr>
        <p:sp>
          <p:nvSpPr>
            <p:cNvPr id="118" name=""/>
            <p:cNvSpPr/>
            <p:nvPr/>
          </p:nvSpPr>
          <p:spPr>
            <a:xfrm>
              <a:off x="3699000" y="5300640"/>
              <a:ext cx="974520" cy="244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just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5,810,922 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2857680" y="5300640"/>
              <a:ext cx="974520" cy="244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just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6,496,261 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2022480" y="5300640"/>
              <a:ext cx="974880" cy="244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just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Total genom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3699000" y="5097240"/>
              <a:ext cx="974520" cy="244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just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-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2857680" y="5097240"/>
              <a:ext cx="974520" cy="244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just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574 032 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2022480" y="5097240"/>
              <a:ext cx="974880" cy="244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just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Plasmid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3699000" y="4894200"/>
              <a:ext cx="974520" cy="244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just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,094,509 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2857680" y="4894200"/>
              <a:ext cx="974520" cy="244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just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,502,411 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2022480" y="4894200"/>
              <a:ext cx="974880" cy="244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just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Chromosome 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3699000" y="4690800"/>
              <a:ext cx="974520" cy="244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just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3,716,413 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2857680" y="4690800"/>
              <a:ext cx="974520" cy="244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just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3,419,818 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2022480" y="4690800"/>
              <a:ext cx="974880" cy="244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just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Chromosome 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3699000" y="4448160"/>
              <a:ext cx="1136520" cy="30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just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GB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R. solanacearu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2857680" y="4448160"/>
              <a:ext cx="974520" cy="30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just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GB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C. taiwanensi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2098800" y="4676760"/>
              <a:ext cx="2520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2098800" y="5497200"/>
              <a:ext cx="2520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4" name=""/>
          <p:cNvSpPr/>
          <p:nvPr/>
        </p:nvSpPr>
        <p:spPr>
          <a:xfrm>
            <a:off x="2016000" y="7873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2016000" y="43243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2016000" y="583416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7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7-16T11:41:19Z</dcterms:created>
  <dc:creator>cmasson</dc:creator>
  <dc:description/>
  <dc:language>en-US</dc:language>
  <cp:lastModifiedBy>capela</cp:lastModifiedBy>
  <dcterms:modified xsi:type="dcterms:W3CDTF">2009-11-17T15:34:51Z</dcterms:modified>
  <cp:revision>10</cp:revision>
  <dc:subject/>
  <dc:title>Diapositive 1</dc:title>
</cp:coreProperties>
</file>